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1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3" autoAdjust="0"/>
    <p:restoredTop sz="94660"/>
  </p:normalViewPr>
  <p:slideViewPr>
    <p:cSldViewPr snapToGrid="0">
      <p:cViewPr>
        <p:scale>
          <a:sx n="190" d="100"/>
          <a:sy n="190" d="100"/>
        </p:scale>
        <p:origin x="738" y="-237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30B0B-E77F-43DD-B190-C62B7DFDEDD7}" type="datetimeFigureOut">
              <a:rPr lang="en-US" smtClean="0"/>
              <a:t>5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66DC3-F86E-47DE-8FCE-7F482AFDB1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27417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30B0B-E77F-43DD-B190-C62B7DFDEDD7}" type="datetimeFigureOut">
              <a:rPr lang="en-US" smtClean="0"/>
              <a:t>5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66DC3-F86E-47DE-8FCE-7F482AFDB1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79537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30B0B-E77F-43DD-B190-C62B7DFDEDD7}" type="datetimeFigureOut">
              <a:rPr lang="en-US" smtClean="0"/>
              <a:t>5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66DC3-F86E-47DE-8FCE-7F482AFDB1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56137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30B0B-E77F-43DD-B190-C62B7DFDEDD7}" type="datetimeFigureOut">
              <a:rPr lang="en-US" smtClean="0"/>
              <a:t>5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66DC3-F86E-47DE-8FCE-7F482AFDB1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59070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30B0B-E77F-43DD-B190-C62B7DFDEDD7}" type="datetimeFigureOut">
              <a:rPr lang="en-US" smtClean="0"/>
              <a:t>5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66DC3-F86E-47DE-8FCE-7F482AFDB1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39118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30B0B-E77F-43DD-B190-C62B7DFDEDD7}" type="datetimeFigureOut">
              <a:rPr lang="en-US" smtClean="0"/>
              <a:t>5/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66DC3-F86E-47DE-8FCE-7F482AFDB1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11940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30B0B-E77F-43DD-B190-C62B7DFDEDD7}" type="datetimeFigureOut">
              <a:rPr lang="en-US" smtClean="0"/>
              <a:t>5/9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66DC3-F86E-47DE-8FCE-7F482AFDB1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4596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30B0B-E77F-43DD-B190-C62B7DFDEDD7}" type="datetimeFigureOut">
              <a:rPr lang="en-US" smtClean="0"/>
              <a:t>5/9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66DC3-F86E-47DE-8FCE-7F482AFDB1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3610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30B0B-E77F-43DD-B190-C62B7DFDEDD7}" type="datetimeFigureOut">
              <a:rPr lang="en-US" smtClean="0"/>
              <a:t>5/9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66DC3-F86E-47DE-8FCE-7F482AFDB1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31132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30B0B-E77F-43DD-B190-C62B7DFDEDD7}" type="datetimeFigureOut">
              <a:rPr lang="en-US" smtClean="0"/>
              <a:t>5/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66DC3-F86E-47DE-8FCE-7F482AFDB1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30218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30B0B-E77F-43DD-B190-C62B7DFDEDD7}" type="datetimeFigureOut">
              <a:rPr lang="en-US" smtClean="0"/>
              <a:t>5/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66DC3-F86E-47DE-8FCE-7F482AFDB1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69502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DB30B0B-E77F-43DD-B190-C62B7DFDEDD7}" type="datetimeFigureOut">
              <a:rPr lang="en-US" smtClean="0"/>
              <a:t>5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FE66DC3-F86E-47DE-8FCE-7F482AFDB1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62801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299F95D-ED9C-5CC2-D7A6-783B912EB59B}"/>
              </a:ext>
            </a:extLst>
          </p:cNvPr>
          <p:cNvSpPr txBox="1"/>
          <p:nvPr/>
        </p:nvSpPr>
        <p:spPr>
          <a:xfrm>
            <a:off x="907249" y="3143022"/>
            <a:ext cx="3203166" cy="470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27" dirty="0"/>
              <a:t>Supplementary Table 1:   Clinical Representativeness</a:t>
            </a: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15303ED1-4F45-ED21-E914-18EA5182C9B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95211445"/>
              </p:ext>
            </p:extLst>
          </p:nvPr>
        </p:nvGraphicFramePr>
        <p:xfrm>
          <a:off x="907249" y="3613022"/>
          <a:ext cx="4518861" cy="2267851"/>
        </p:xfrm>
        <a:graphic>
          <a:graphicData uri="http://schemas.openxmlformats.org/drawingml/2006/table">
            <a:tbl>
              <a:tblPr firstRow="1" bandRow="1">
                <a:tableStyleId>{3B4B98B0-60AC-42C2-AFA5-B58CD77FA1E5}</a:tableStyleId>
              </a:tblPr>
              <a:tblGrid>
                <a:gridCol w="703350">
                  <a:extLst>
                    <a:ext uri="{9D8B030D-6E8A-4147-A177-3AD203B41FA5}">
                      <a16:colId xmlns:a16="http://schemas.microsoft.com/office/drawing/2014/main" val="3878936585"/>
                    </a:ext>
                  </a:extLst>
                </a:gridCol>
                <a:gridCol w="3815511">
                  <a:extLst>
                    <a:ext uri="{9D8B030D-6E8A-4147-A177-3AD203B41FA5}">
                      <a16:colId xmlns:a16="http://schemas.microsoft.com/office/drawing/2014/main" val="786556928"/>
                    </a:ext>
                  </a:extLst>
                </a:gridCol>
              </a:tblGrid>
              <a:tr h="25414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400">
                          <a:solidFill>
                            <a:srgbClr val="333333"/>
                          </a:solidFill>
                          <a:effectLst/>
                        </a:rPr>
                        <a:t>Cancer type /subtype/stage</a:t>
                      </a:r>
                      <a:endParaRPr lang="en-US" sz="500">
                        <a:effectLst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400">
                          <a:solidFill>
                            <a:srgbClr val="333333"/>
                          </a:solidFill>
                          <a:effectLst/>
                        </a:rPr>
                        <a:t>/condition</a:t>
                      </a:r>
                      <a:endParaRPr lang="en-US" sz="5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43294" marR="43294" marT="43294" marB="43294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400" dirty="0">
                          <a:solidFill>
                            <a:srgbClr val="333333"/>
                          </a:solidFill>
                          <a:effectLst/>
                        </a:rPr>
                        <a:t>ERBB2 amplified and/or Her2 overexpressing metastatic colorectal cancer </a:t>
                      </a:r>
                      <a:endParaRPr lang="en-US" sz="500" dirty="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43294" marR="43294" marT="43294" marB="43294" anchor="ctr"/>
                </a:tc>
                <a:extLst>
                  <a:ext uri="{0D108BD9-81ED-4DB2-BD59-A6C34878D82A}">
                    <a16:rowId xmlns:a16="http://schemas.microsoft.com/office/drawing/2014/main" val="3910126281"/>
                  </a:ext>
                </a:extLst>
              </a:tr>
              <a:tr h="145635">
                <a:tc gridSpan="2"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400" dirty="0">
                          <a:solidFill>
                            <a:srgbClr val="333333"/>
                          </a:solidFill>
                          <a:effectLst/>
                        </a:rPr>
                        <a:t>Considerations related to:</a:t>
                      </a:r>
                    </a:p>
                  </a:txBody>
                  <a:tcPr marL="43294" marR="43294" marT="43294" marB="43294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57220929"/>
                  </a:ext>
                </a:extLst>
              </a:tr>
              <a:tr h="280064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400" dirty="0">
                          <a:solidFill>
                            <a:srgbClr val="333333"/>
                          </a:solidFill>
                          <a:effectLst/>
                        </a:rPr>
                        <a:t>Sex</a:t>
                      </a:r>
                      <a:endParaRPr lang="en-US" sz="500" dirty="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43294" marR="43294" marT="43294" marB="43294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400" dirty="0">
                          <a:solidFill>
                            <a:srgbClr val="333333"/>
                          </a:solidFill>
                          <a:effectLst/>
                        </a:rPr>
                        <a:t>ERBB2 amplified colorectal cancer is a rare subset (1-6%) of overall stage IV CRC so there are few large datasets with a gender breakdown.  One real-world dataset</a:t>
                      </a:r>
                      <a:r>
                        <a:rPr lang="en-US" sz="400" baseline="30000" dirty="0">
                          <a:solidFill>
                            <a:srgbClr val="333333"/>
                          </a:solidFill>
                          <a:effectLst/>
                        </a:rPr>
                        <a:t>1</a:t>
                      </a:r>
                      <a:r>
                        <a:rPr lang="en-US" sz="400" dirty="0">
                          <a:solidFill>
                            <a:srgbClr val="333333"/>
                          </a:solidFill>
                          <a:effectLst/>
                        </a:rPr>
                        <a:t> suggests a slightly higher prevalence of the subset in males (56%).  Our cohort contained 62% males.</a:t>
                      </a:r>
                      <a:endParaRPr lang="en-US" sz="500" dirty="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43294" marR="43294" marT="43294" marB="43294"/>
                </a:tc>
                <a:extLst>
                  <a:ext uri="{0D108BD9-81ED-4DB2-BD59-A6C34878D82A}">
                    <a16:rowId xmlns:a16="http://schemas.microsoft.com/office/drawing/2014/main" val="1413814639"/>
                  </a:ext>
                </a:extLst>
              </a:tr>
              <a:tr h="22988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400">
                          <a:solidFill>
                            <a:srgbClr val="333333"/>
                          </a:solidFill>
                          <a:effectLst/>
                        </a:rPr>
                        <a:t>Age</a:t>
                      </a:r>
                      <a:endParaRPr lang="en-US" sz="5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43294" marR="43294" marT="43294" marB="43294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400" dirty="0">
                          <a:solidFill>
                            <a:srgbClr val="333333"/>
                          </a:solidFill>
                          <a:effectLst/>
                        </a:rPr>
                        <a:t>The median age at diagnosis for Her2 positive colorectal cancer patients is between 55-65 years. This tends to be slightly younger than the median age for all colorectal cancer cases, which is around 68-72 years. In our study the median age was 54.</a:t>
                      </a:r>
                      <a:endParaRPr lang="en-US" sz="500" dirty="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43294" marR="43294" marT="43294" marB="43294"/>
                </a:tc>
                <a:extLst>
                  <a:ext uri="{0D108BD9-81ED-4DB2-BD59-A6C34878D82A}">
                    <a16:rowId xmlns:a16="http://schemas.microsoft.com/office/drawing/2014/main" val="480300004"/>
                  </a:ext>
                </a:extLst>
              </a:tr>
              <a:tr h="280064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400">
                          <a:solidFill>
                            <a:srgbClr val="333333"/>
                          </a:solidFill>
                          <a:effectLst/>
                        </a:rPr>
                        <a:t>Race/ethnicity</a:t>
                      </a:r>
                      <a:endParaRPr lang="en-US" sz="5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43294" marR="43294" marT="43294" marB="43294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400" dirty="0">
                          <a:solidFill>
                            <a:srgbClr val="333333"/>
                          </a:solidFill>
                          <a:effectLst/>
                        </a:rPr>
                        <a:t>ERBB2 amplified colorectal cancer is observed across racial and ethnic groups.  Schroder et al observed 58% White, 11% Black or African-American, 7 % Asian and 6% Hispanic or Latino and ~15% other.  In  our cohort, there were 85% White, 9% Black or African-American, 4% Asian and 2% other.</a:t>
                      </a:r>
                      <a:endParaRPr lang="en-US" sz="500" dirty="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43294" marR="43294" marT="43294" marB="43294"/>
                </a:tc>
                <a:extLst>
                  <a:ext uri="{0D108BD9-81ED-4DB2-BD59-A6C34878D82A}">
                    <a16:rowId xmlns:a16="http://schemas.microsoft.com/office/drawing/2014/main" val="679418005"/>
                  </a:ext>
                </a:extLst>
              </a:tr>
              <a:tr h="293643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400">
                          <a:solidFill>
                            <a:srgbClr val="333333"/>
                          </a:solidFill>
                          <a:effectLst/>
                        </a:rPr>
                        <a:t>Geography</a:t>
                      </a:r>
                      <a:endParaRPr lang="en-US" sz="5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43294" marR="43294" marT="43294" marB="43294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400" dirty="0">
                          <a:solidFill>
                            <a:srgbClr val="333333"/>
                          </a:solidFill>
                          <a:effectLst/>
                        </a:rPr>
                        <a:t>The incidence of colorectal cancer in the United States, where this study enrolled, was higher in men (41.5 per 100,000) than in women (31.2 per 100,000) between 2015-2019</a:t>
                      </a:r>
                      <a:r>
                        <a:rPr lang="en-US" sz="400" baseline="30000" dirty="0">
                          <a:solidFill>
                            <a:srgbClr val="333333"/>
                          </a:solidFill>
                          <a:effectLst/>
                        </a:rPr>
                        <a:t>2</a:t>
                      </a:r>
                      <a:r>
                        <a:rPr lang="en-US" sz="400" dirty="0">
                          <a:solidFill>
                            <a:srgbClr val="333333"/>
                          </a:solidFill>
                          <a:effectLst/>
                        </a:rPr>
                        <a:t>. Detailed geographical data specific to Her2 positive cases are not readily available for the US where this study was enrolled.</a:t>
                      </a:r>
                      <a:endParaRPr lang="en-US" sz="500" dirty="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43294" marR="43294" marT="43294" marB="43294"/>
                </a:tc>
                <a:extLst>
                  <a:ext uri="{0D108BD9-81ED-4DB2-BD59-A6C34878D82A}">
                    <a16:rowId xmlns:a16="http://schemas.microsoft.com/office/drawing/2014/main" val="1489597471"/>
                  </a:ext>
                </a:extLst>
              </a:tr>
              <a:tr h="280064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400">
                          <a:solidFill>
                            <a:srgbClr val="333333"/>
                          </a:solidFill>
                          <a:effectLst/>
                        </a:rPr>
                        <a:t>Other considerations</a:t>
                      </a:r>
                      <a:endParaRPr lang="en-US" sz="5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43294" marR="43294" marT="43294" marB="43294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400" dirty="0">
                          <a:solidFill>
                            <a:srgbClr val="333333"/>
                          </a:solidFill>
                          <a:effectLst/>
                        </a:rPr>
                        <a:t>Few studies of Her2 positive colorectal cancer have been published and those that have, do not report patient breakdown by race/ethnicity.   </a:t>
                      </a:r>
                      <a:endParaRPr lang="en-US" sz="500" dirty="0">
                        <a:effectLst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400" dirty="0">
                          <a:solidFill>
                            <a:srgbClr val="333333"/>
                          </a:solidFill>
                          <a:effectLst/>
                        </a:rPr>
                        <a:t> </a:t>
                      </a:r>
                      <a:endParaRPr lang="en-US" sz="500" dirty="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43294" marR="43294" marT="43294" marB="43294"/>
                </a:tc>
                <a:extLst>
                  <a:ext uri="{0D108BD9-81ED-4DB2-BD59-A6C34878D82A}">
                    <a16:rowId xmlns:a16="http://schemas.microsoft.com/office/drawing/2014/main" val="1521454969"/>
                  </a:ext>
                </a:extLst>
              </a:tr>
              <a:tr h="458036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400">
                          <a:solidFill>
                            <a:srgbClr val="333333"/>
                          </a:solidFill>
                          <a:effectLst/>
                        </a:rPr>
                        <a:t>Overall representativeness of this study</a:t>
                      </a:r>
                      <a:endParaRPr lang="en-US" sz="5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43294" marR="43294" marT="43294" marB="43294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400" dirty="0">
                          <a:solidFill>
                            <a:srgbClr val="333333"/>
                          </a:solidFill>
                          <a:effectLst/>
                        </a:rPr>
                        <a:t>In our study ~10% (4/42) of reported patients with plasma samples available are black, a similar proportion to the Schroder paper</a:t>
                      </a:r>
                      <a:r>
                        <a:rPr lang="en-US" sz="400" baseline="30000" dirty="0">
                          <a:solidFill>
                            <a:srgbClr val="333333"/>
                          </a:solidFill>
                          <a:effectLst/>
                        </a:rPr>
                        <a:t>1</a:t>
                      </a:r>
                      <a:r>
                        <a:rPr lang="en-US" sz="400" dirty="0">
                          <a:solidFill>
                            <a:srgbClr val="333333"/>
                          </a:solidFill>
                          <a:effectLst/>
                        </a:rPr>
                        <a:t>.</a:t>
                      </a:r>
                      <a:endParaRPr lang="en-US" sz="500" dirty="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43294" marR="43294" marT="43294" marB="43294"/>
                </a:tc>
                <a:extLst>
                  <a:ext uri="{0D108BD9-81ED-4DB2-BD59-A6C34878D82A}">
                    <a16:rowId xmlns:a16="http://schemas.microsoft.com/office/drawing/2014/main" val="3142277049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17567188-235B-9631-68CE-05F2A6CC7FAB}"/>
              </a:ext>
            </a:extLst>
          </p:cNvPr>
          <p:cNvSpPr txBox="1"/>
          <p:nvPr/>
        </p:nvSpPr>
        <p:spPr>
          <a:xfrm>
            <a:off x="1478105" y="6063483"/>
            <a:ext cx="3203166" cy="3441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233791" indent="-233791">
              <a:buFont typeface="+mj-lt"/>
              <a:buAutoNum type="arabicPeriod"/>
            </a:pPr>
            <a:r>
              <a:rPr lang="en-US" sz="409" dirty="0">
                <a:latin typeface="Arial" panose="020B0604020202020204" pitchFamily="34" charset="0"/>
                <a:ea typeface="Arial" panose="020B0604020202020204" pitchFamily="34" charset="0"/>
              </a:rPr>
              <a:t>Schroder C, Gower-Page C, Reyes-Rivera I, Patel A, Price R, Sen S. et al. Natural History of Human epidermal Growth Factor Receptor 2-Amplified and Human Epidermal Growth Factor Receptor 2 Wild-Type Refractory Metastatic Colorectal Cancer in US Clinical Practice</a:t>
            </a:r>
          </a:p>
          <a:p>
            <a:pPr marL="233791" indent="-233791">
              <a:buFont typeface="+mj-lt"/>
              <a:buAutoNum type="arabicPeriod"/>
            </a:pPr>
            <a:r>
              <a:rPr lang="en-US" sz="409" dirty="0">
                <a:latin typeface="Arial" panose="020B0604020202020204" pitchFamily="34" charset="0"/>
                <a:ea typeface="Arial" panose="020B0604020202020204" pitchFamily="34" charset="0"/>
              </a:rPr>
              <a:t>American Cancer Society. Colorectal Cancer Facts &amp; Figures 2023-2025. Atlanta: American Cancer Society; 2023.</a:t>
            </a:r>
          </a:p>
        </p:txBody>
      </p:sp>
    </p:spTree>
    <p:extLst>
      <p:ext uri="{BB962C8B-B14F-4D97-AF65-F5344CB8AC3E}">
        <p14:creationId xmlns:p14="http://schemas.microsoft.com/office/powerpoint/2010/main" val="8562924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377</Words>
  <Application>Microsoft Office PowerPoint</Application>
  <PresentationFormat>Widescreen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iegmann, Bill</dc:creator>
  <cp:lastModifiedBy>Siegmann, Bill</cp:lastModifiedBy>
  <cp:revision>1</cp:revision>
  <dcterms:created xsi:type="dcterms:W3CDTF">2025-05-09T15:47:06Z</dcterms:created>
  <dcterms:modified xsi:type="dcterms:W3CDTF">2025-05-09T15:51:50Z</dcterms:modified>
</cp:coreProperties>
</file>